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2" r:id="rId3"/>
    <p:sldId id="268" r:id="rId4"/>
    <p:sldId id="270" r:id="rId5"/>
    <p:sldId id="263" r:id="rId6"/>
    <p:sldId id="269" r:id="rId7"/>
    <p:sldId id="265" r:id="rId8"/>
    <p:sldId id="271" r:id="rId9"/>
    <p:sldId id="266" r:id="rId10"/>
    <p:sldId id="267" r:id="rId11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565" autoAdjust="0"/>
    <p:restoredTop sz="94660"/>
  </p:normalViewPr>
  <p:slideViewPr>
    <p:cSldViewPr snapToGrid="0">
      <p:cViewPr varScale="1">
        <p:scale>
          <a:sx n="60" d="100"/>
          <a:sy n="60" d="100"/>
        </p:scale>
        <p:origin x="2899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598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399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68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177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348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917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724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760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528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900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7661B-CDD3-4A3A-BAC6-F06E373F4538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7F0F4B-407A-4C02-A443-14C5E128AA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607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w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212D8A93-6213-4597-93FF-D7BA70D93247}"/>
              </a:ext>
            </a:extLst>
          </p:cNvPr>
          <p:cNvSpPr txBox="1"/>
          <p:nvPr/>
        </p:nvSpPr>
        <p:spPr>
          <a:xfrm>
            <a:off x="1166537" y="8523514"/>
            <a:ext cx="5316255" cy="70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chart of the experimental steps for screening tolerance to Sulfur deficiency in rice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ED89018-5F1D-4DE6-A021-55139DFF1386}"/>
              </a:ext>
            </a:extLst>
          </p:cNvPr>
          <p:cNvGrpSpPr/>
          <p:nvPr/>
        </p:nvGrpSpPr>
        <p:grpSpPr>
          <a:xfrm>
            <a:off x="1783435" y="1382486"/>
            <a:ext cx="3503198" cy="7021423"/>
            <a:chOff x="1783435" y="1382486"/>
            <a:chExt cx="3503198" cy="7021423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6E423BE4-697A-4C9B-859C-4F627692F5A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46084" y="1382486"/>
              <a:ext cx="3440549" cy="6901817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51FACB60-417B-4693-9C1E-79748B84F80B}"/>
                </a:ext>
              </a:extLst>
            </p:cNvPr>
            <p:cNvSpPr/>
            <p:nvPr/>
          </p:nvSpPr>
          <p:spPr>
            <a:xfrm>
              <a:off x="1783435" y="8067791"/>
              <a:ext cx="1596912" cy="33611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s: days after sowing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201103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473CC7D-E161-4E23-927B-BDBF2C152728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820" b="19343"/>
          <a:stretch/>
        </p:blipFill>
        <p:spPr bwMode="auto">
          <a:xfrm>
            <a:off x="1628159" y="1049786"/>
            <a:ext cx="4102735" cy="622490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D9E272B-43D7-4C90-A7A0-3815AC799316}"/>
              </a:ext>
            </a:extLst>
          </p:cNvPr>
          <p:cNvSpPr txBox="1"/>
          <p:nvPr/>
        </p:nvSpPr>
        <p:spPr>
          <a:xfrm>
            <a:off x="1000699" y="7412101"/>
            <a:ext cx="5357653" cy="6131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-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 alignment for the sulfotransferase gene Os11g0505300 (LOC_Os11g30910) and DJ123.</a:t>
            </a:r>
          </a:p>
        </p:txBody>
      </p:sp>
    </p:spTree>
    <p:extLst>
      <p:ext uri="{BB962C8B-B14F-4D97-AF65-F5344CB8AC3E}">
        <p14:creationId xmlns:p14="http://schemas.microsoft.com/office/powerpoint/2010/main" val="36020041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C09CABA-4EDA-4842-AA35-03EC94D03E7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4636" t="32031" r="5058" b="29889"/>
          <a:stretch/>
        </p:blipFill>
        <p:spPr>
          <a:xfrm>
            <a:off x="2119376" y="1679673"/>
            <a:ext cx="2931262" cy="138822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8923810-B4F5-4E1B-84C0-76697472B823}"/>
              </a:ext>
            </a:extLst>
          </p:cNvPr>
          <p:cNvSpPr txBox="1"/>
          <p:nvPr/>
        </p:nvSpPr>
        <p:spPr>
          <a:xfrm>
            <a:off x="987390" y="6094796"/>
            <a:ext cx="5288719" cy="982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xperiment 1. Plant growth in 0- and 0.01-mM Sulfur treatment (A). Different stages of leaf symptoms induced by S-deficiency treatment (B).</a:t>
            </a:r>
          </a:p>
          <a:p>
            <a:pPr algn="just">
              <a:lnSpc>
                <a:spcPct val="150000"/>
              </a:lnSpc>
            </a:pP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A117A7E1-8E74-42CC-A008-5CB48E219925}"/>
              </a:ext>
            </a:extLst>
          </p:cNvPr>
          <p:cNvGrpSpPr/>
          <p:nvPr/>
        </p:nvGrpSpPr>
        <p:grpSpPr>
          <a:xfrm>
            <a:off x="2139507" y="3439307"/>
            <a:ext cx="2931262" cy="2282620"/>
            <a:chOff x="2707538" y="3273053"/>
            <a:chExt cx="3305335" cy="262791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4696FD7-5E13-4658-AB80-9B4894DEA1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2712643" y="3949078"/>
              <a:ext cx="3300230" cy="59975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913F466-B77B-43F3-8259-1C7BCFEAFB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2707538" y="4626878"/>
              <a:ext cx="3294924" cy="570573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FCC33A9-F0AB-4F0D-8901-2885E38790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2712643" y="5280256"/>
              <a:ext cx="3300230" cy="62071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E3B0C8E-4C6D-486E-A1F0-26B80AFF44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2712645" y="3273053"/>
              <a:ext cx="3300228" cy="595530"/>
            </a:xfrm>
            <a:prstGeom prst="rect">
              <a:avLst/>
            </a:prstGeom>
          </p:spPr>
        </p:pic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C8D4E66A-6185-4843-BFE7-77107B56B90B}"/>
              </a:ext>
            </a:extLst>
          </p:cNvPr>
          <p:cNvSpPr txBox="1"/>
          <p:nvPr/>
        </p:nvSpPr>
        <p:spPr>
          <a:xfrm>
            <a:off x="1730608" y="1302410"/>
            <a:ext cx="182330" cy="3772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37AA2CC-9823-4D27-9D00-037A3BC59039}"/>
              </a:ext>
            </a:extLst>
          </p:cNvPr>
          <p:cNvSpPr txBox="1"/>
          <p:nvPr/>
        </p:nvSpPr>
        <p:spPr>
          <a:xfrm>
            <a:off x="1756147" y="3067901"/>
            <a:ext cx="182330" cy="3772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AC252C8-F114-4060-BA05-C682E2CC6800}"/>
              </a:ext>
            </a:extLst>
          </p:cNvPr>
          <p:cNvSpPr txBox="1"/>
          <p:nvPr/>
        </p:nvSpPr>
        <p:spPr>
          <a:xfrm>
            <a:off x="4277919" y="1681139"/>
            <a:ext cx="595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 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4F29CA0-03C9-4A7D-BA6D-EA00D87A1B96}"/>
              </a:ext>
            </a:extLst>
          </p:cNvPr>
          <p:cNvSpPr txBox="1"/>
          <p:nvPr/>
        </p:nvSpPr>
        <p:spPr>
          <a:xfrm>
            <a:off x="2318743" y="1679673"/>
            <a:ext cx="1288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.01 mM S</a:t>
            </a:r>
          </a:p>
        </p:txBody>
      </p:sp>
    </p:spTree>
    <p:extLst>
      <p:ext uri="{BB962C8B-B14F-4D97-AF65-F5344CB8AC3E}">
        <p14:creationId xmlns:p14="http://schemas.microsoft.com/office/powerpoint/2010/main" val="39093784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6CC66EB-9A91-4E34-872F-CAA0AC496ADE}"/>
              </a:ext>
            </a:extLst>
          </p:cNvPr>
          <p:cNvSpPr/>
          <p:nvPr/>
        </p:nvSpPr>
        <p:spPr>
          <a:xfrm>
            <a:off x="2061919" y="1257520"/>
            <a:ext cx="13115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kern="100" dirty="0">
                <a:solidFill>
                  <a:srgbClr val="0D0D0D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) Root length:</a:t>
            </a:r>
            <a:endParaRPr lang="en-US" sz="1400" i="1" kern="100" dirty="0"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DC92A2A-CDE1-4F59-AC70-94C27B887568}"/>
              </a:ext>
            </a:extLst>
          </p:cNvPr>
          <p:cNvSpPr/>
          <p:nvPr/>
        </p:nvSpPr>
        <p:spPr>
          <a:xfrm>
            <a:off x="2097164" y="3520480"/>
            <a:ext cx="15953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kern="100" dirty="0">
                <a:solidFill>
                  <a:srgbClr val="0D0D0D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) Root dry matter:</a:t>
            </a:r>
            <a:endParaRPr lang="en-US" sz="1400" i="1" kern="100" dirty="0"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5DECFB6-E0D7-4E3A-80D8-EC8EE49AD9BF}"/>
              </a:ext>
            </a:extLst>
          </p:cNvPr>
          <p:cNvSpPr/>
          <p:nvPr/>
        </p:nvSpPr>
        <p:spPr>
          <a:xfrm>
            <a:off x="2109418" y="5749205"/>
            <a:ext cx="160832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kern="100" dirty="0">
                <a:solidFill>
                  <a:srgbClr val="0D0D0D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C) Total dry matter:</a:t>
            </a:r>
            <a:endParaRPr lang="en-US" sz="1400" i="1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0BE665B-175C-4380-BF7F-3B2FADC4EF85}"/>
              </a:ext>
            </a:extLst>
          </p:cNvPr>
          <p:cNvSpPr/>
          <p:nvPr/>
        </p:nvSpPr>
        <p:spPr>
          <a:xfrm>
            <a:off x="844442" y="8127798"/>
            <a:ext cx="544390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-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hattan plots derived from GWAS analysis for traits: A) Root length, B) Root dry matter, and C) total dry matter in high-S treatment. Manhattan plot shows negative logarithmic ((-log10 (P)) values of association for each SNP (Y axis), and SNP location along the 12 chromosomes (colored bar in X axis). Red line indicates a -log10 (P value) threshold of 5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9F5C27-D456-40AD-8DAC-9DF60884C672}"/>
              </a:ext>
            </a:extLst>
          </p:cNvPr>
          <p:cNvSpPr txBox="1"/>
          <p:nvPr/>
        </p:nvSpPr>
        <p:spPr>
          <a:xfrm>
            <a:off x="2132416" y="1757680"/>
            <a:ext cx="815293" cy="99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B86C228C-332D-4A91-9D63-B59030EB3B29}"/>
              </a:ext>
            </a:extLst>
          </p:cNvPr>
          <p:cNvGrpSpPr/>
          <p:nvPr/>
        </p:nvGrpSpPr>
        <p:grpSpPr>
          <a:xfrm>
            <a:off x="1949307" y="3815342"/>
            <a:ext cx="3082321" cy="1771356"/>
            <a:chOff x="459720" y="3815342"/>
            <a:chExt cx="3082321" cy="1771356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0CE053A2-0B18-44A8-AAF2-CA6FDE60366F}"/>
                </a:ext>
              </a:extLst>
            </p:cNvPr>
            <p:cNvGrpSpPr/>
            <p:nvPr/>
          </p:nvGrpSpPr>
          <p:grpSpPr>
            <a:xfrm>
              <a:off x="490429" y="3846066"/>
              <a:ext cx="3051612" cy="1740632"/>
              <a:chOff x="490429" y="3846066"/>
              <a:chExt cx="3051612" cy="1740632"/>
            </a:xfrm>
          </p:grpSpPr>
          <p:pic>
            <p:nvPicPr>
              <p:cNvPr id="11" name="Picture 10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A888D06B-311A-46FD-A335-C4BFDCBDE7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0429" y="3846066"/>
                <a:ext cx="2921533" cy="1623074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6821B54E-5BDE-4F38-8FFB-D7ED81CF48EE}"/>
                  </a:ext>
                </a:extLst>
              </p:cNvPr>
              <p:cNvSpPr txBox="1"/>
              <p:nvPr/>
            </p:nvSpPr>
            <p:spPr>
              <a:xfrm>
                <a:off x="674613" y="5371254"/>
                <a:ext cx="2867428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1          2          3         4        5        6      7       8     9    10    11   12</a:t>
                </a: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C5414B4-228F-4EFB-B82E-01D291BF9A95}"/>
                </a:ext>
              </a:extLst>
            </p:cNvPr>
            <p:cNvSpPr txBox="1"/>
            <p:nvPr/>
          </p:nvSpPr>
          <p:spPr>
            <a:xfrm>
              <a:off x="459720" y="3815342"/>
              <a:ext cx="815293" cy="996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3A57029-6307-4403-A831-29663DEF9125}"/>
              </a:ext>
            </a:extLst>
          </p:cNvPr>
          <p:cNvGrpSpPr/>
          <p:nvPr/>
        </p:nvGrpSpPr>
        <p:grpSpPr>
          <a:xfrm>
            <a:off x="1980016" y="6115697"/>
            <a:ext cx="3020093" cy="1757261"/>
            <a:chOff x="490429" y="6198576"/>
            <a:chExt cx="3020093" cy="1757261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38052323-7401-4910-BC58-A207D9CFCB6F}"/>
                </a:ext>
              </a:extLst>
            </p:cNvPr>
            <p:cNvGrpSpPr/>
            <p:nvPr/>
          </p:nvGrpSpPr>
          <p:grpSpPr>
            <a:xfrm>
              <a:off x="490429" y="6218146"/>
              <a:ext cx="3020093" cy="1737691"/>
              <a:chOff x="490429" y="6218146"/>
              <a:chExt cx="3020093" cy="1737691"/>
            </a:xfrm>
          </p:grpSpPr>
          <p:pic>
            <p:nvPicPr>
              <p:cNvPr id="16" name="Picture 15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6362B9EA-71BC-45DE-A178-337BC6B5C8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0429" y="6218146"/>
                <a:ext cx="2921533" cy="1623074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0249EB58-B2C1-4D00-8AA7-8D4D9AC41467}"/>
                  </a:ext>
                </a:extLst>
              </p:cNvPr>
              <p:cNvSpPr txBox="1"/>
              <p:nvPr/>
            </p:nvSpPr>
            <p:spPr>
              <a:xfrm>
                <a:off x="643094" y="7740393"/>
                <a:ext cx="2867428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1          2          3         4        5        6      7       8      9    10    11   12</a:t>
                </a: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28D7C81-F1BB-4188-A446-DF067FADE25D}"/>
                </a:ext>
              </a:extLst>
            </p:cNvPr>
            <p:cNvSpPr txBox="1"/>
            <p:nvPr/>
          </p:nvSpPr>
          <p:spPr>
            <a:xfrm>
              <a:off x="490429" y="6198576"/>
              <a:ext cx="815293" cy="9964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CA234E50-78C2-45B1-8364-18B2804D69A1}"/>
              </a:ext>
            </a:extLst>
          </p:cNvPr>
          <p:cNvGrpSpPr/>
          <p:nvPr/>
        </p:nvGrpSpPr>
        <p:grpSpPr>
          <a:xfrm>
            <a:off x="1980016" y="1626246"/>
            <a:ext cx="3038163" cy="1737169"/>
            <a:chOff x="490429" y="1626246"/>
            <a:chExt cx="3038163" cy="1737169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504DF6EF-0F5B-4C90-B5B8-D3EC490184FD}"/>
                </a:ext>
              </a:extLst>
            </p:cNvPr>
            <p:cNvGrpSpPr/>
            <p:nvPr/>
          </p:nvGrpSpPr>
          <p:grpSpPr>
            <a:xfrm>
              <a:off x="490429" y="1638201"/>
              <a:ext cx="3038163" cy="1725214"/>
              <a:chOff x="490429" y="1638201"/>
              <a:chExt cx="3038163" cy="1725214"/>
            </a:xfrm>
          </p:grpSpPr>
          <p:pic>
            <p:nvPicPr>
              <p:cNvPr id="21" name="Picture 20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3D0D8593-B90D-4C05-91F9-E81196E937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0429" y="1638201"/>
                <a:ext cx="2921533" cy="1600935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54902A45-7B56-45FB-ABE2-4B652963A154}"/>
                  </a:ext>
                </a:extLst>
              </p:cNvPr>
              <p:cNvSpPr txBox="1"/>
              <p:nvPr/>
            </p:nvSpPr>
            <p:spPr>
              <a:xfrm>
                <a:off x="661164" y="3147971"/>
                <a:ext cx="2867428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1          2          3         4        5        6      7       8     9    10    11   12</a:t>
                </a:r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E0B10BB-36BC-4507-87F5-A61EF9815273}"/>
                </a:ext>
              </a:extLst>
            </p:cNvPr>
            <p:cNvSpPr txBox="1"/>
            <p:nvPr/>
          </p:nvSpPr>
          <p:spPr>
            <a:xfrm>
              <a:off x="490429" y="1626246"/>
              <a:ext cx="815293" cy="9964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A6901D6B-FE2A-47A9-9641-40578EBF0211}"/>
              </a:ext>
            </a:extLst>
          </p:cNvPr>
          <p:cNvCxnSpPr>
            <a:cxnSpLocks/>
          </p:cNvCxnSpPr>
          <p:nvPr/>
        </p:nvCxnSpPr>
        <p:spPr>
          <a:xfrm>
            <a:off x="2084193" y="6705600"/>
            <a:ext cx="2788920" cy="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9FE81314-02C8-4462-99AC-BBF49AD33C7C}"/>
              </a:ext>
            </a:extLst>
          </p:cNvPr>
          <p:cNvCxnSpPr>
            <a:cxnSpLocks/>
          </p:cNvCxnSpPr>
          <p:nvPr/>
        </p:nvCxnSpPr>
        <p:spPr>
          <a:xfrm>
            <a:off x="2084193" y="2206752"/>
            <a:ext cx="2788920" cy="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15DFC4B-E419-4506-8BC9-F4D6977F32DA}"/>
              </a:ext>
            </a:extLst>
          </p:cNvPr>
          <p:cNvCxnSpPr>
            <a:cxnSpLocks/>
          </p:cNvCxnSpPr>
          <p:nvPr/>
        </p:nvCxnSpPr>
        <p:spPr>
          <a:xfrm>
            <a:off x="2097164" y="4413504"/>
            <a:ext cx="2788920" cy="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109370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D3CDB795-AF71-40D4-9D52-92932582BD4A}"/>
              </a:ext>
            </a:extLst>
          </p:cNvPr>
          <p:cNvSpPr/>
          <p:nvPr/>
        </p:nvSpPr>
        <p:spPr>
          <a:xfrm>
            <a:off x="1460090" y="703509"/>
            <a:ext cx="13115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kern="100" dirty="0">
                <a:solidFill>
                  <a:srgbClr val="0D0D0D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) Root length:</a:t>
            </a:r>
            <a:endParaRPr lang="en-US" sz="1400" i="1" kern="100" dirty="0"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919F63E-A1B3-4CA6-A2D3-FC4A0AF0818D}"/>
              </a:ext>
            </a:extLst>
          </p:cNvPr>
          <p:cNvSpPr/>
          <p:nvPr/>
        </p:nvSpPr>
        <p:spPr>
          <a:xfrm>
            <a:off x="1542638" y="3166654"/>
            <a:ext cx="159530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kern="100" dirty="0">
                <a:solidFill>
                  <a:srgbClr val="0D0D0D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) Root dry matter:</a:t>
            </a:r>
            <a:endParaRPr lang="en-US" sz="1400" i="1" kern="100" dirty="0"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7BCBD73-3A7A-4296-A56E-FC638B62FAE3}"/>
              </a:ext>
            </a:extLst>
          </p:cNvPr>
          <p:cNvSpPr/>
          <p:nvPr/>
        </p:nvSpPr>
        <p:spPr>
          <a:xfrm>
            <a:off x="1542638" y="5585594"/>
            <a:ext cx="160832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kern="100" dirty="0">
                <a:solidFill>
                  <a:srgbClr val="0D0D0D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C) Total dry matter:</a:t>
            </a:r>
            <a:endParaRPr lang="en-US" sz="1400" i="1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60560F0-23F3-4EFA-9131-31A76967002B}"/>
              </a:ext>
            </a:extLst>
          </p:cNvPr>
          <p:cNvSpPr/>
          <p:nvPr/>
        </p:nvSpPr>
        <p:spPr>
          <a:xfrm>
            <a:off x="757013" y="8000496"/>
            <a:ext cx="550693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kern="100" dirty="0">
                <a:solidFill>
                  <a:srgbClr val="0D0D0D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3-2</a:t>
            </a:r>
            <a:r>
              <a:rPr lang="en-US" sz="1400" kern="100" dirty="0">
                <a:solidFill>
                  <a:srgbClr val="0D0D0D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Manhattan plots derived from GWAS analysis for traits: A) Root length, B) Root dry matter, and C) total dry matter using relative values for low-S/high-S treatments. Manhattan plot shows negative logarithmic ((-log10 (P)) values of association for each SNP (Y axis), and SNP location along the 12 chromosomes (colored bar in X axis). Red line indicates a -log10 (P value) threshold of 5. </a:t>
            </a:r>
            <a:endParaRPr lang="en-US" sz="1400" kern="100" dirty="0">
              <a:latin typeface="Calibri" panose="020F050202020403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0A521317-420F-4BBC-B579-F1C92444B0F6}"/>
              </a:ext>
            </a:extLst>
          </p:cNvPr>
          <p:cNvGrpSpPr/>
          <p:nvPr/>
        </p:nvGrpSpPr>
        <p:grpSpPr>
          <a:xfrm>
            <a:off x="1218561" y="5950300"/>
            <a:ext cx="3341038" cy="1803927"/>
            <a:chOff x="1218561" y="5950300"/>
            <a:chExt cx="3341038" cy="1803927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43554957-B322-465D-A458-50EC7EF4E2B2}"/>
                </a:ext>
              </a:extLst>
            </p:cNvPr>
            <p:cNvGrpSpPr/>
            <p:nvPr/>
          </p:nvGrpSpPr>
          <p:grpSpPr>
            <a:xfrm>
              <a:off x="1471469" y="5983109"/>
              <a:ext cx="3088130" cy="1771118"/>
              <a:chOff x="1471469" y="5983109"/>
              <a:chExt cx="3088130" cy="1771118"/>
            </a:xfrm>
          </p:grpSpPr>
          <p:pic>
            <p:nvPicPr>
              <p:cNvPr id="9" name="Picture 8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C1C44557-43CF-4B4D-9789-7F63F33DD3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71469" y="5983109"/>
                <a:ext cx="2994113" cy="1663396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783BF48-148B-409F-940E-2F6E5FCA4EA9}"/>
                  </a:ext>
                </a:extLst>
              </p:cNvPr>
              <p:cNvSpPr txBox="1"/>
              <p:nvPr/>
            </p:nvSpPr>
            <p:spPr>
              <a:xfrm>
                <a:off x="1692171" y="7538783"/>
                <a:ext cx="2867428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1          2          3         4        5        6      7       8     9    10    11    12</a:t>
                </a: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20C670F-9B62-434B-8EEF-65D8963AC7CB}"/>
                </a:ext>
              </a:extLst>
            </p:cNvPr>
            <p:cNvSpPr txBox="1"/>
            <p:nvPr/>
          </p:nvSpPr>
          <p:spPr>
            <a:xfrm>
              <a:off x="1218561" y="5950300"/>
              <a:ext cx="947220" cy="1324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DEF68B84-D918-4E97-9B2A-EBB9E1176B90}"/>
              </a:ext>
            </a:extLst>
          </p:cNvPr>
          <p:cNvGrpSpPr/>
          <p:nvPr/>
        </p:nvGrpSpPr>
        <p:grpSpPr>
          <a:xfrm>
            <a:off x="1393072" y="3551212"/>
            <a:ext cx="3134447" cy="1827908"/>
            <a:chOff x="1393072" y="3551212"/>
            <a:chExt cx="3134447" cy="1827908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2BA2387C-0AFA-4474-B556-851F1C6F239F}"/>
                </a:ext>
              </a:extLst>
            </p:cNvPr>
            <p:cNvGrpSpPr/>
            <p:nvPr/>
          </p:nvGrpSpPr>
          <p:grpSpPr>
            <a:xfrm>
              <a:off x="1478241" y="3608002"/>
              <a:ext cx="3049278" cy="1771118"/>
              <a:chOff x="1475491" y="3608141"/>
              <a:chExt cx="3049278" cy="1771118"/>
            </a:xfrm>
          </p:grpSpPr>
          <p:pic>
            <p:nvPicPr>
              <p:cNvPr id="14" name="Picture 13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702DE0AB-4608-450B-8620-8D63704C6F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75491" y="3608141"/>
                <a:ext cx="2994113" cy="1663396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2AC3E36-C8E7-420C-B9A2-DCDE5295B7DF}"/>
                  </a:ext>
                </a:extLst>
              </p:cNvPr>
              <p:cNvSpPr txBox="1"/>
              <p:nvPr/>
            </p:nvSpPr>
            <p:spPr>
              <a:xfrm>
                <a:off x="1657341" y="5163815"/>
                <a:ext cx="2867428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1          2          3         4        5        6      7       8     9    10    11    12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368EF1D-28B6-4FAB-99E3-6720EDB2578D}"/>
                </a:ext>
              </a:extLst>
            </p:cNvPr>
            <p:cNvSpPr txBox="1"/>
            <p:nvPr/>
          </p:nvSpPr>
          <p:spPr>
            <a:xfrm>
              <a:off x="1393072" y="3551212"/>
              <a:ext cx="947220" cy="1324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FDE5C8B7-427B-4A2C-8B3E-C86E478582B2}"/>
              </a:ext>
            </a:extLst>
          </p:cNvPr>
          <p:cNvGrpSpPr/>
          <p:nvPr/>
        </p:nvGrpSpPr>
        <p:grpSpPr>
          <a:xfrm>
            <a:off x="1237684" y="1210953"/>
            <a:ext cx="3333977" cy="1780001"/>
            <a:chOff x="1237684" y="1210953"/>
            <a:chExt cx="3333977" cy="1780001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ACB00294-6EF1-4725-85AA-E9DBFCF3B782}"/>
                </a:ext>
              </a:extLst>
            </p:cNvPr>
            <p:cNvGrpSpPr/>
            <p:nvPr/>
          </p:nvGrpSpPr>
          <p:grpSpPr>
            <a:xfrm>
              <a:off x="1478241" y="1210953"/>
              <a:ext cx="3093420" cy="1780001"/>
              <a:chOff x="1478241" y="1210953"/>
              <a:chExt cx="3093420" cy="1780001"/>
            </a:xfrm>
          </p:grpSpPr>
          <p:pic>
            <p:nvPicPr>
              <p:cNvPr id="19" name="Picture 18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706AD7D2-7623-46D3-B705-5086AE84392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78241" y="1210953"/>
                <a:ext cx="2994113" cy="1663396"/>
              </a:xfrm>
              <a:prstGeom prst="rect">
                <a:avLst/>
              </a:prstGeom>
            </p:spPr>
          </p:pic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310BF072-FB22-4889-9AAB-B2CBEC07D416}"/>
                  </a:ext>
                </a:extLst>
              </p:cNvPr>
              <p:cNvSpPr txBox="1"/>
              <p:nvPr/>
            </p:nvSpPr>
            <p:spPr>
              <a:xfrm>
                <a:off x="1704233" y="2775510"/>
                <a:ext cx="2867428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   1          2          3         4        5        6      7       8     9    10    11    12</a:t>
                </a:r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25654F3-3CD7-431D-8DC7-2B6F11E7669F}"/>
                </a:ext>
              </a:extLst>
            </p:cNvPr>
            <p:cNvSpPr txBox="1"/>
            <p:nvPr/>
          </p:nvSpPr>
          <p:spPr>
            <a:xfrm>
              <a:off x="1237684" y="1210953"/>
              <a:ext cx="947220" cy="1324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24F8629-64A8-47C9-AA0C-F743BF740FDC}"/>
              </a:ext>
            </a:extLst>
          </p:cNvPr>
          <p:cNvCxnSpPr>
            <a:cxnSpLocks/>
          </p:cNvCxnSpPr>
          <p:nvPr/>
        </p:nvCxnSpPr>
        <p:spPr>
          <a:xfrm>
            <a:off x="1564236" y="6565392"/>
            <a:ext cx="2876962" cy="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A3058B0C-5349-444F-BDD7-4FC35DB533F5}"/>
              </a:ext>
            </a:extLst>
          </p:cNvPr>
          <p:cNvCxnSpPr>
            <a:cxnSpLocks/>
          </p:cNvCxnSpPr>
          <p:nvPr/>
        </p:nvCxnSpPr>
        <p:spPr>
          <a:xfrm>
            <a:off x="1571008" y="2380270"/>
            <a:ext cx="2876962" cy="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AA07DE5-A1ED-458B-9354-348EAE1DCFF2}"/>
              </a:ext>
            </a:extLst>
          </p:cNvPr>
          <p:cNvCxnSpPr>
            <a:cxnSpLocks/>
          </p:cNvCxnSpPr>
          <p:nvPr/>
        </p:nvCxnSpPr>
        <p:spPr>
          <a:xfrm>
            <a:off x="1558140" y="4267200"/>
            <a:ext cx="2876962" cy="0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414580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7F23215-F2CF-4696-B25B-A46177623C50}"/>
              </a:ext>
            </a:extLst>
          </p:cNvPr>
          <p:cNvSpPr txBox="1"/>
          <p:nvPr/>
        </p:nvSpPr>
        <p:spPr>
          <a:xfrm>
            <a:off x="898468" y="4009299"/>
            <a:ext cx="1413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UE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790B4D7-0A4F-4654-B24A-9B0C6011B67A}"/>
              </a:ext>
            </a:extLst>
          </p:cNvPr>
          <p:cNvSpPr txBox="1"/>
          <p:nvPr/>
        </p:nvSpPr>
        <p:spPr>
          <a:xfrm>
            <a:off x="887674" y="1017629"/>
            <a:ext cx="15936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UE2-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15BB76C-5FBF-4EA3-AECA-6CF741145F6B}"/>
              </a:ext>
            </a:extLst>
          </p:cNvPr>
          <p:cNvSpPr txBox="1"/>
          <p:nvPr/>
        </p:nvSpPr>
        <p:spPr>
          <a:xfrm>
            <a:off x="898468" y="6600560"/>
            <a:ext cx="1413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UE1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5F2550F-AE9D-4327-95C9-853AF1B75081}"/>
              </a:ext>
            </a:extLst>
          </p:cNvPr>
          <p:cNvSpPr txBox="1"/>
          <p:nvPr/>
        </p:nvSpPr>
        <p:spPr>
          <a:xfrm>
            <a:off x="882303" y="3721753"/>
            <a:ext cx="2154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ot dry matter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7A0B645-49D5-44EE-ACF9-47F396E7BF13}"/>
              </a:ext>
            </a:extLst>
          </p:cNvPr>
          <p:cNvSpPr txBox="1"/>
          <p:nvPr/>
        </p:nvSpPr>
        <p:spPr>
          <a:xfrm>
            <a:off x="448540" y="8992621"/>
            <a:ext cx="59799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kage disequilibrium (LD) block produced by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loview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.</a:t>
            </a:r>
            <a:endParaRPr lang="en-US" sz="1400" dirty="0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9A7C50F5-36E2-4234-A990-EEDD5629B276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6332" y="4323211"/>
            <a:ext cx="1714500" cy="176212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8A75192-D5C7-4DF9-9956-37E8A43E5A59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84382" y="1298499"/>
            <a:ext cx="1759355" cy="209987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4AC827E-D317-4D52-970B-F1DFFF9714CB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07390" y="6942323"/>
            <a:ext cx="1852580" cy="1646738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36C0D82D-9EF2-4315-95B8-52B804433DB1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29306" y="1298499"/>
            <a:ext cx="1759356" cy="209987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3284F90C-382F-4934-A2F2-AA8D79A9E870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84382" y="6936735"/>
            <a:ext cx="1759355" cy="183230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F9D15FB-9FCE-4354-B95B-C8014E592309}"/>
              </a:ext>
            </a:extLst>
          </p:cNvPr>
          <p:cNvSpPr txBox="1"/>
          <p:nvPr/>
        </p:nvSpPr>
        <p:spPr>
          <a:xfrm>
            <a:off x="3707390" y="1017629"/>
            <a:ext cx="106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UE9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BDC7648-505F-4A66-83A1-8029F7A421AB}"/>
              </a:ext>
            </a:extLst>
          </p:cNvPr>
          <p:cNvSpPr txBox="1"/>
          <p:nvPr/>
        </p:nvSpPr>
        <p:spPr>
          <a:xfrm>
            <a:off x="789110" y="698749"/>
            <a:ext cx="2414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ot length </a:t>
            </a:r>
            <a:endParaRPr 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727E916-482A-4681-8473-D6EFF61ACB1B}"/>
              </a:ext>
            </a:extLst>
          </p:cNvPr>
          <p:cNvSpPr txBox="1"/>
          <p:nvPr/>
        </p:nvSpPr>
        <p:spPr>
          <a:xfrm>
            <a:off x="882304" y="6292783"/>
            <a:ext cx="2154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dry matter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C23594F-C789-4A1C-A1FB-6ACB2075547C}"/>
              </a:ext>
            </a:extLst>
          </p:cNvPr>
          <p:cNvSpPr txBox="1"/>
          <p:nvPr/>
        </p:nvSpPr>
        <p:spPr>
          <a:xfrm>
            <a:off x="3673287" y="6569341"/>
            <a:ext cx="1413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UE3-1</a:t>
            </a:r>
          </a:p>
        </p:txBody>
      </p:sp>
    </p:spTree>
    <p:extLst>
      <p:ext uri="{BB962C8B-B14F-4D97-AF65-F5344CB8AC3E}">
        <p14:creationId xmlns:p14="http://schemas.microsoft.com/office/powerpoint/2010/main" val="15730912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EC4E764-E0C4-4720-A0C0-48FA31E531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2268" y="675772"/>
            <a:ext cx="2473255" cy="165194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115FA89-9018-43ED-92C6-1861E79709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2268" y="2428575"/>
            <a:ext cx="2473255" cy="165194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032434E-84F2-453C-BD36-5517F36E2A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92269" y="4260830"/>
            <a:ext cx="2473256" cy="165194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293976D-BF04-4BF9-A577-E75438DE31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92268" y="6081123"/>
            <a:ext cx="2473255" cy="165194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45983D9-7F55-477C-AB0C-75F5FDEF11D2}"/>
              </a:ext>
            </a:extLst>
          </p:cNvPr>
          <p:cNvSpPr txBox="1"/>
          <p:nvPr/>
        </p:nvSpPr>
        <p:spPr>
          <a:xfrm>
            <a:off x="606597" y="7851172"/>
            <a:ext cx="5644806" cy="22159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atio of phenotypic values of low-S/high-S treatments for Root length (A), root dry matter (B), total dry matter (C) an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ot:shoo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tio (D). Genotypes included in the box harbor the favorable haplotype for total dry matter. SUR: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j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kh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HAR: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rbhoond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KHA: Khadasiya3; CHU: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gu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li; AND: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ikula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P: NP 125; SAN: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nth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faid207; KAN: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ngro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JUM: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um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NCS: NCS 160; DJ: DJ123.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letters above horizontal lines indicate significant differences within factor S treatment; while those above bars indicate significance within factor genotype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864B2BA-8F8A-4FAE-9EDB-72A0E02F4F06}"/>
              </a:ext>
            </a:extLst>
          </p:cNvPr>
          <p:cNvSpPr txBox="1"/>
          <p:nvPr/>
        </p:nvSpPr>
        <p:spPr>
          <a:xfrm flipH="1" flipV="1">
            <a:off x="1157021" y="3034906"/>
            <a:ext cx="461665" cy="2977520"/>
          </a:xfrm>
          <a:prstGeom prst="rect">
            <a:avLst/>
          </a:prstGeom>
          <a:noFill/>
          <a:ln>
            <a:noFill/>
          </a:ln>
        </p:spPr>
        <p:txBody>
          <a:bodyPr vert="vert" wrap="square" rtlCol="0">
            <a:spAutoFit/>
          </a:bodyPr>
          <a:lstStyle/>
          <a:p>
            <a:r>
              <a:rPr lang="en-US" dirty="0"/>
              <a:t>Relative value: Low S/High 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C5FCB1B-0619-49E9-947C-11F2C4224D99}"/>
              </a:ext>
            </a:extLst>
          </p:cNvPr>
          <p:cNvSpPr txBox="1"/>
          <p:nvPr/>
        </p:nvSpPr>
        <p:spPr>
          <a:xfrm>
            <a:off x="1558522" y="676522"/>
            <a:ext cx="3337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CD2FAF7-5938-4BE8-A970-5B0CB4FFFFD6}"/>
              </a:ext>
            </a:extLst>
          </p:cNvPr>
          <p:cNvSpPr txBox="1"/>
          <p:nvPr/>
        </p:nvSpPr>
        <p:spPr>
          <a:xfrm>
            <a:off x="1558356" y="2447067"/>
            <a:ext cx="3706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31C9CB1-3428-4440-A38D-A65BD3345913}"/>
              </a:ext>
            </a:extLst>
          </p:cNvPr>
          <p:cNvSpPr txBox="1"/>
          <p:nvPr/>
        </p:nvSpPr>
        <p:spPr>
          <a:xfrm>
            <a:off x="1558356" y="4091506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C364214-6090-4828-BE0D-056F694A1A3C}"/>
              </a:ext>
            </a:extLst>
          </p:cNvPr>
          <p:cNvSpPr txBox="1"/>
          <p:nvPr/>
        </p:nvSpPr>
        <p:spPr>
          <a:xfrm>
            <a:off x="1537518" y="5981648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D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DD48C57-99EF-4C84-9AFB-86064A3CE39A}"/>
              </a:ext>
            </a:extLst>
          </p:cNvPr>
          <p:cNvSpPr/>
          <p:nvPr/>
        </p:nvSpPr>
        <p:spPr>
          <a:xfrm>
            <a:off x="3072384" y="7522450"/>
            <a:ext cx="963168" cy="2078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12054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C534E64-0F71-48D3-9EC9-3DF06F4DD3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7346" y="796003"/>
            <a:ext cx="4273995" cy="698506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E497B02-F6F1-4BD6-96A7-6A5C4E2E0EB3}"/>
              </a:ext>
            </a:extLst>
          </p:cNvPr>
          <p:cNvSpPr txBox="1"/>
          <p:nvPr/>
        </p:nvSpPr>
        <p:spPr>
          <a:xfrm>
            <a:off x="1100832" y="7871203"/>
            <a:ext cx="4983325" cy="10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-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 alignment for both sulfotransferase genes Os11g0503900 and Os11g0505300, based on the referenc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pponbar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. </a:t>
            </a:r>
          </a:p>
        </p:txBody>
      </p:sp>
    </p:spTree>
    <p:extLst>
      <p:ext uri="{BB962C8B-B14F-4D97-AF65-F5344CB8AC3E}">
        <p14:creationId xmlns:p14="http://schemas.microsoft.com/office/powerpoint/2010/main" val="4604003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BC1EA2F5-7D98-4D8B-988F-17869EEE12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49" name="Picture 1">
            <a:extLst>
              <a:ext uri="{FF2B5EF4-FFF2-40B4-BE49-F238E27FC236}">
                <a16:creationId xmlns:a16="http://schemas.microsoft.com/office/drawing/2014/main" id="{1AA9A1CF-6CDD-4EDF-ABEE-E1171D4897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013" b="75053"/>
          <a:stretch>
            <a:fillRect/>
          </a:stretch>
        </p:blipFill>
        <p:spPr bwMode="auto">
          <a:xfrm>
            <a:off x="1119981" y="1566453"/>
            <a:ext cx="4618037" cy="19256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9A30BDC-999E-41F3-9AF8-6551FC39A1E1}"/>
              </a:ext>
            </a:extLst>
          </p:cNvPr>
          <p:cNvSpPr txBox="1"/>
          <p:nvPr/>
        </p:nvSpPr>
        <p:spPr>
          <a:xfrm>
            <a:off x="811132" y="3711228"/>
            <a:ext cx="5357653" cy="13056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-2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lignment of partial nucleotide sequence for Sulfotransferase gene Os11g0503900 i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nth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faid207, DJ123 an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j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kh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>
              <a:lnSpc>
                <a:spcPct val="150000"/>
              </a:lnSpc>
            </a:pP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06460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08265B5-ED1B-478C-9DD4-4D76990DB9C5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602" b="18887"/>
          <a:stretch/>
        </p:blipFill>
        <p:spPr bwMode="auto">
          <a:xfrm>
            <a:off x="1309053" y="1376680"/>
            <a:ext cx="4061460" cy="625983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453AC1-43CA-404E-96F0-A762E0F275A9}"/>
              </a:ext>
            </a:extLst>
          </p:cNvPr>
          <p:cNvSpPr txBox="1"/>
          <p:nvPr/>
        </p:nvSpPr>
        <p:spPr>
          <a:xfrm>
            <a:off x="541363" y="7816153"/>
            <a:ext cx="5357653" cy="70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-3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 alignment for the sulfotransferase gene Os11g0503900 (LOC_Os11g30810) and DJ123.</a:t>
            </a:r>
          </a:p>
        </p:txBody>
      </p:sp>
    </p:spTree>
    <p:extLst>
      <p:ext uri="{BB962C8B-B14F-4D97-AF65-F5344CB8AC3E}">
        <p14:creationId xmlns:p14="http://schemas.microsoft.com/office/powerpoint/2010/main" val="4078887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65</TotalTime>
  <Words>586</Words>
  <Application>Microsoft Office PowerPoint</Application>
  <PresentationFormat>A4 Paper (210x297 mm)</PresentationFormat>
  <Paragraphs>41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an</dc:creator>
  <cp:lastModifiedBy>Juan</cp:lastModifiedBy>
  <cp:revision>70</cp:revision>
  <dcterms:created xsi:type="dcterms:W3CDTF">2017-12-11T08:00:49Z</dcterms:created>
  <dcterms:modified xsi:type="dcterms:W3CDTF">2019-12-19T02:09:14Z</dcterms:modified>
</cp:coreProperties>
</file>